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945EEC7-5351-42D2-9F7C-D0D285C38D3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A75B6EF6-C9AB-4E89-B9CD-60787E7D55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495FE38-2041-45B9-A292-6B36F97EE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43AE2-EE0A-4C81-8CC6-AD1134389BD8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CEC3D0F-7CBF-4BFC-BAE7-252440F71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E17D5BA-532C-407D-98E7-9BF752AD12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52939-8282-4BF2-B6CC-7834475F080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985487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411E27D-1E87-46E6-9BCC-41416A5FD6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AD89482-ACF7-4620-B34F-66CFD83D05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EA112E0-CEC5-4F66-86B6-1330E29E3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43AE2-EE0A-4C81-8CC6-AD1134389BD8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00040D6-EE74-4D26-8669-2FA6FA6A64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3A835E6-C390-450E-8893-613ECD994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52939-8282-4BF2-B6CC-7834475F080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63115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BA720BF7-ED18-4406-91FD-BEF8282DBB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30475DC2-5A43-4BE5-A847-1F8E157C0E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BAC1BC9-4882-4A31-92DA-973DE07AE4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43AE2-EE0A-4C81-8CC6-AD1134389BD8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49C6CFB-2D4F-49CF-961F-EB6F463CC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D357362-477A-4290-AC9D-00BCE3A17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52939-8282-4BF2-B6CC-7834475F080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27264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6C0127B-C68A-4103-9E6C-14F0E286CA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DB14853-3EE2-43A6-A683-B27F7B45C7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EC19D11-0759-4325-AC70-9696AA764B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43AE2-EE0A-4C81-8CC6-AD1134389BD8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69C29AA-6ADE-4B92-9310-D23344E31E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06D4F8F-671E-49CF-9290-0833604D1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52939-8282-4BF2-B6CC-7834475F080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2323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2C96C80-436F-482F-BEDB-BE62063321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4521CD0-94E2-4DFF-ACDC-4336F0B067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C4AD0BC-8A7F-42E5-ADA5-4C249A8E63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43AE2-EE0A-4C81-8CC6-AD1134389BD8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7F2DDEA-8ACB-49A5-9993-9DA3C95DF4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C165DE6-7372-4CAA-A1F7-7C5355273F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52939-8282-4BF2-B6CC-7834475F080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17629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1B3C0F5-5328-4329-8DBC-6A82BEA477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B05701B-58A7-48B6-9AED-90D53BCD0B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11F4A70-A8EE-4B3A-A17E-A8E8000D78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3A3EDBF-E6B8-447D-967C-E45BC28CE9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43AE2-EE0A-4C81-8CC6-AD1134389BD8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C231996-731D-4DE7-A1C8-BF0E5BE2DD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41506EB-84F8-4CAE-82F1-AA1E92F79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52939-8282-4BF2-B6CC-7834475F080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97797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4F724F7-A82A-4B81-BC0D-47E918FCDF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9FEC87B-CFAE-4661-B98E-467F028423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90A9457-DE5B-4CB0-AE45-66A21CB943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D764C3DB-4D7B-48B9-B207-F102453632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2B52483B-3C96-4E17-A4A9-81BFDCE40A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F77DAE50-0660-4E86-A0F5-8392247703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43AE2-EE0A-4C81-8CC6-AD1134389BD8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CEFC568E-41DD-4B51-A8CA-2AB597B91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84818F6B-B74D-4244-AB6B-B2051D14C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52939-8282-4BF2-B6CC-7834475F080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766102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2184190-A207-48F5-AD1A-EB14F266E8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918E2D6C-80DD-48A2-BE1E-DEB68F99A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43AE2-EE0A-4C81-8CC6-AD1134389BD8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BA3D3FDA-9B88-42C4-A48D-4F23407D23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7CFAC695-D166-4A35-97F7-06C9296924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52939-8282-4BF2-B6CC-7834475F080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49512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C37C252E-8AD5-4AD1-835C-341C091DE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43AE2-EE0A-4C81-8CC6-AD1134389BD8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C980954E-C24B-469C-AA37-CE361A2180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30B64AD5-06CC-4877-A2AF-78BC3A05D5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52939-8282-4BF2-B6CC-7834475F080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21956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18B51AF-D183-47FE-A2F9-CBCE1B6C7B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339235A-E0E1-4372-BBBE-27002E964B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71CE603-C8AF-4966-A8EC-F662928F63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F591F1E-D868-41B3-AEA6-5353CC38A4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43AE2-EE0A-4C81-8CC6-AD1134389BD8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FB61489-17E4-4A9C-AB0B-9220BF95B5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851CCE9-56DC-4DB8-9478-8CB2E0BB3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52939-8282-4BF2-B6CC-7834475F080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40150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F335251-D8CC-421D-B3DB-6BA420906B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85E7CA7F-37E0-4480-BE9A-A6FE55DC64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1A378EF-58B6-43F7-A4FD-E54ACD2FFC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2E19B3B-ECF3-4EDD-9300-0559AC1DA3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F43AE2-EE0A-4C81-8CC6-AD1134389BD8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84F328A-53C3-4818-919F-25D85639E4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14710A9-BFDD-4713-8AFE-77B983EBB8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452939-8282-4BF2-B6CC-7834475F080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30203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9BD5685F-6B6A-49F4-8C3A-FB9703627D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6426843-16FE-4C29-9527-C84697B4F7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53911C0-B67E-43CA-93E0-8D9FE42BB2D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F43AE2-EE0A-4C81-8CC6-AD1134389BD8}" type="datetimeFigureOut">
              <a:rPr lang="es-MX" smtClean="0"/>
              <a:t>06/09/2019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942F9F3-5DBD-4666-9881-A780C2937E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E364ED6-AEE0-4936-9E64-9B58E299D9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452939-8282-4BF2-B6CC-7834475F0809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32236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D812F759-F5B7-405F-829E-AB6A932B1D6B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960223" y="277812"/>
            <a:ext cx="4114800" cy="3010535"/>
          </a:xfrm>
          <a:prstGeom prst="rect">
            <a:avLst/>
          </a:prstGeom>
        </p:spPr>
      </p:pic>
      <p:sp>
        <p:nvSpPr>
          <p:cNvPr id="5" name="Rectángulo 4">
            <a:extLst>
              <a:ext uri="{FF2B5EF4-FFF2-40B4-BE49-F238E27FC236}">
                <a16:creationId xmlns:a16="http://schemas.microsoft.com/office/drawing/2014/main" id="{D2AD07C2-D455-4168-A652-B04A2EDA6B4B}"/>
              </a:ext>
            </a:extLst>
          </p:cNvPr>
          <p:cNvSpPr/>
          <p:nvPr/>
        </p:nvSpPr>
        <p:spPr>
          <a:xfrm>
            <a:off x="3457303" y="3592287"/>
            <a:ext cx="6096000" cy="1384995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Bef>
                <a:spcPts val="1200"/>
              </a:spcBef>
              <a:spcAft>
                <a:spcPts val="12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Corroboration of the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L6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levels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R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CR assays to confirm the overexpression of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l6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OETal6 and the null expression in Δtal6 strains. RNA from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. atroviride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rain was used as positive control. Internal primers to amplify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l6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were used. Glyceraldehyde-3- phosphate dehydrogenase gene (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pd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as used as an endogenous expression control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RT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PCR assay was done by quadruplicate with three technical replicates each one. Data were analyzed using an ANOVA non-parametric test with P&lt;0.05.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l6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ll mutants and overexpressing strains had significant differences with respect to the wild type.</a:t>
            </a:r>
            <a:endParaRPr lang="es-MX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230129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08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ulina Guzmán Guzmán</dc:creator>
  <cp:lastModifiedBy>Paulina Guzmán Guzmán</cp:lastModifiedBy>
  <cp:revision>2</cp:revision>
  <dcterms:created xsi:type="dcterms:W3CDTF">2019-09-06T14:34:09Z</dcterms:created>
  <dcterms:modified xsi:type="dcterms:W3CDTF">2019-09-06T14:35:53Z</dcterms:modified>
</cp:coreProperties>
</file>